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1" r:id="rId2"/>
  </p:sldIdLst>
  <p:sldSz cx="6858000" cy="9144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BB2FF"/>
    <a:srgbClr val="000000"/>
    <a:srgbClr val="D8BEEC"/>
    <a:srgbClr val="DFC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52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524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164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664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080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85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35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34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6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59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94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71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97CEAFA-EDF5-56A3-5B34-622202D78A67}"/>
              </a:ext>
            </a:extLst>
          </p:cNvPr>
          <p:cNvSpPr txBox="1"/>
          <p:nvPr/>
        </p:nvSpPr>
        <p:spPr>
          <a:xfrm>
            <a:off x="257575" y="346708"/>
            <a:ext cx="734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S5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C529D45-ECD0-B0F8-8DB0-3412647F1A0C}"/>
              </a:ext>
            </a:extLst>
          </p:cNvPr>
          <p:cNvSpPr txBox="1"/>
          <p:nvPr/>
        </p:nvSpPr>
        <p:spPr>
          <a:xfrm>
            <a:off x="632601" y="6568428"/>
            <a:ext cx="55220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33375" indent="-333375" algn="just"/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 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S5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 Quantitative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CR analysis for the genes potentially involved in gluconeogenesis in developing 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zebrafish.  Dots and lines indicate values of individual samples (N=4) and the mean of the groups, respectively.  x- and y- axes indicate developmental time in hours post fertilization (hpf) and expression levels in (target mRNA / </a:t>
            </a:r>
            <a:r>
              <a:rPr lang="en-US" altLang="ja-JP" sz="1000" i="1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pl13a 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RNA</a:t>
            </a:r>
            <a:r>
              <a:rPr lang="en-US" altLang="ja-JP" sz="1000" i="1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respectively.</a:t>
            </a:r>
            <a:endParaRPr lang="ja-JP" altLang="ja-JP" sz="10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5554FAC-EA88-D4F3-7D2E-CBB16F9F271C}"/>
              </a:ext>
            </a:extLst>
          </p:cNvPr>
          <p:cNvGrpSpPr/>
          <p:nvPr/>
        </p:nvGrpSpPr>
        <p:grpSpPr>
          <a:xfrm>
            <a:off x="991655" y="1401317"/>
            <a:ext cx="4988417" cy="4868730"/>
            <a:chOff x="991655" y="1401317"/>
            <a:chExt cx="4988417" cy="4868730"/>
          </a:xfrm>
        </p:grpSpPr>
        <p:pic>
          <p:nvPicPr>
            <p:cNvPr id="9" name="図 8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8A576E9E-A823-578F-5A49-6E4AA9126F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1655" y="1401317"/>
              <a:ext cx="2199588" cy="1622910"/>
            </a:xfrm>
            <a:prstGeom prst="rect">
              <a:avLst/>
            </a:prstGeom>
          </p:spPr>
        </p:pic>
        <p:pic>
          <p:nvPicPr>
            <p:cNvPr id="14" name="図 13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764BF751-6FC9-0B9B-5846-F87721C659B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0484" y="4647137"/>
              <a:ext cx="2197803" cy="1622910"/>
            </a:xfrm>
            <a:prstGeom prst="rect">
              <a:avLst/>
            </a:prstGeom>
          </p:spPr>
        </p:pic>
        <p:pic>
          <p:nvPicPr>
            <p:cNvPr id="19" name="図 18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8702B1D9-2FD3-FA74-E7B5-21AED841773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1655" y="3024227"/>
              <a:ext cx="2533457" cy="1628269"/>
            </a:xfrm>
            <a:prstGeom prst="rect">
              <a:avLst/>
            </a:prstGeom>
          </p:spPr>
        </p:pic>
        <p:pic>
          <p:nvPicPr>
            <p:cNvPr id="224" name="図 223" descr="グラフ&#10;&#10;自動的に生成された説明">
              <a:extLst>
                <a:ext uri="{FF2B5EF4-FFF2-40B4-BE49-F238E27FC236}">
                  <a16:creationId xmlns:a16="http://schemas.microsoft.com/office/drawing/2014/main" id="{DD5CE675-8F5C-AE21-8C73-DC36EC3EE90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0484" y="3029586"/>
              <a:ext cx="2199588" cy="1622910"/>
            </a:xfrm>
            <a:prstGeom prst="rect">
              <a:avLst/>
            </a:prstGeom>
          </p:spPr>
        </p:pic>
        <p:pic>
          <p:nvPicPr>
            <p:cNvPr id="226" name="図 225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208A0C24-E3C7-1822-5160-1CAC9585E2C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0484" y="1401317"/>
              <a:ext cx="2151383" cy="1622910"/>
            </a:xfrm>
            <a:prstGeom prst="rect">
              <a:avLst/>
            </a:prstGeom>
          </p:spPr>
        </p:pic>
        <p:pic>
          <p:nvPicPr>
            <p:cNvPr id="227" name="図 226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FDFDC44C-1635-310C-054C-FE0BBB5DDA0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1655" y="4647137"/>
              <a:ext cx="2199588" cy="162291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14855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1</TotalTime>
  <Words>72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miya Furukawa</dc:creator>
  <cp:lastModifiedBy>Fumiya Furukawa</cp:lastModifiedBy>
  <cp:revision>129</cp:revision>
  <cp:lastPrinted>2022-03-19T03:19:24Z</cp:lastPrinted>
  <dcterms:created xsi:type="dcterms:W3CDTF">2021-06-01T22:46:36Z</dcterms:created>
  <dcterms:modified xsi:type="dcterms:W3CDTF">2024-02-15T11:46:40Z</dcterms:modified>
</cp:coreProperties>
</file>